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stelakara\Desktop\Nl\Western%20blot%20figure%204%20VCaP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C:\Users\stelakara\Desktop\Nl\Western%20blot%20figure%204%20VCaP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elakara\Desktop\Nl\Western%20blot%20figure%204%20VCaP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elakara\Desktop\Nl\Western%20blot%20figure%204%20VCaP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3198149181452491E-2"/>
          <c:y val="5.7802131761574921E-2"/>
          <c:w val="0.65019722018089998"/>
          <c:h val="0.81697972977681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-VCaP'!$X$59</c:f>
              <c:strCache>
                <c:ptCount val="1"/>
                <c:pt idx="0">
                  <c:v>DMSO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X$69:$X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'sk-VCaP'!$X$69:$X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X$60:$X$64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sk-VCaP'!$Y$59</c:f>
              <c:strCache>
                <c:ptCount val="1"/>
                <c:pt idx="0">
                  <c:v>DOCETAXE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Y$69:$Y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735026918962568E-2</c:v>
                  </c:pt>
                  <c:pt idx="2">
                    <c:v>3.2093507326048459E-2</c:v>
                  </c:pt>
                  <c:pt idx="3">
                    <c:v>0.13017082793177809</c:v>
                  </c:pt>
                  <c:pt idx="4">
                    <c:v>3.2093507326048459E-2</c:v>
                  </c:pt>
                </c:numCache>
              </c:numRef>
            </c:plus>
            <c:minus>
              <c:numRef>
                <c:f>'sk-VCaP'!$Y$69:$Y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735026918962568E-2</c:v>
                  </c:pt>
                  <c:pt idx="2">
                    <c:v>3.2093507326048459E-2</c:v>
                  </c:pt>
                  <c:pt idx="3">
                    <c:v>0.13017082793177809</c:v>
                  </c:pt>
                  <c:pt idx="4">
                    <c:v>3.2093507326048459E-2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Y$60:$Y$64</c:f>
              <c:numCache>
                <c:formatCode>General</c:formatCode>
                <c:ptCount val="5"/>
                <c:pt idx="0">
                  <c:v>1</c:v>
                </c:pt>
                <c:pt idx="1">
                  <c:v>1.9000000000000001</c:v>
                </c:pt>
                <c:pt idx="2">
                  <c:v>1.056644880174292</c:v>
                </c:pt>
                <c:pt idx="3">
                  <c:v>1.5833333333333333</c:v>
                </c:pt>
                <c:pt idx="4">
                  <c:v>1.3333333333333333</c:v>
                </c:pt>
              </c:numCache>
            </c:numRef>
          </c:val>
        </c:ser>
        <c:ser>
          <c:idx val="2"/>
          <c:order val="2"/>
          <c:tx>
            <c:strRef>
              <c:f>'sk-VCaP'!$Z$59</c:f>
              <c:strCache>
                <c:ptCount val="1"/>
                <c:pt idx="0">
                  <c:v>GLIPR1-ΔT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Z$69:$Z$73</c:f>
                <c:numCache>
                  <c:formatCode>General</c:formatCode>
                  <c:ptCount val="5"/>
                  <c:pt idx="0">
                    <c:v>0.19314471967260272</c:v>
                  </c:pt>
                  <c:pt idx="1">
                    <c:v>4.5511873064609264E-2</c:v>
                  </c:pt>
                  <c:pt idx="2">
                    <c:v>2.5410950046319741E-2</c:v>
                  </c:pt>
                  <c:pt idx="3">
                    <c:v>0.10126079477392437</c:v>
                  </c:pt>
                  <c:pt idx="4">
                    <c:v>2.5410950046319741E-2</c:v>
                  </c:pt>
                </c:numCache>
              </c:numRef>
            </c:plus>
            <c:minus>
              <c:numRef>
                <c:f>'sk-VCaP'!$Z$69:$Z$73</c:f>
                <c:numCache>
                  <c:formatCode>General</c:formatCode>
                  <c:ptCount val="5"/>
                  <c:pt idx="0">
                    <c:v>0.19314471967260272</c:v>
                  </c:pt>
                  <c:pt idx="1">
                    <c:v>4.5511873064609264E-2</c:v>
                  </c:pt>
                  <c:pt idx="2">
                    <c:v>2.5410950046319741E-2</c:v>
                  </c:pt>
                  <c:pt idx="3">
                    <c:v>0.10126079477392437</c:v>
                  </c:pt>
                  <c:pt idx="4">
                    <c:v>2.5410950046319741E-2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Z$60:$Z$64</c:f>
              <c:numCache>
                <c:formatCode>General</c:formatCode>
                <c:ptCount val="5"/>
                <c:pt idx="0">
                  <c:v>1.9843137254901961</c:v>
                </c:pt>
                <c:pt idx="1">
                  <c:v>1.5148148148148148</c:v>
                </c:pt>
                <c:pt idx="2">
                  <c:v>0.69757481940144483</c:v>
                </c:pt>
                <c:pt idx="3">
                  <c:v>0.74705882352941178</c:v>
                </c:pt>
                <c:pt idx="4">
                  <c:v>0.61568627450980384</c:v>
                </c:pt>
              </c:numCache>
            </c:numRef>
          </c:val>
        </c:ser>
        <c:ser>
          <c:idx val="3"/>
          <c:order val="3"/>
          <c:tx>
            <c:strRef>
              <c:f>'sk-VCaP'!$AA$59</c:f>
              <c:strCache>
                <c:ptCount val="1"/>
                <c:pt idx="0">
                  <c:v>DOCETAXEL+GLIPR1-ΔT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AA$69:$AA$73</c:f>
                <c:numCache>
                  <c:formatCode>General</c:formatCode>
                  <c:ptCount val="5"/>
                  <c:pt idx="0">
                    <c:v>0.14442078296721883</c:v>
                  </c:pt>
                  <c:pt idx="1">
                    <c:v>0.23129622216290355</c:v>
                  </c:pt>
                  <c:pt idx="2">
                    <c:v>2.8867513459481284E-2</c:v>
                  </c:pt>
                  <c:pt idx="3">
                    <c:v>4.2189923590861607E-2</c:v>
                  </c:pt>
                  <c:pt idx="4">
                    <c:v>2.8867513459481284E-2</c:v>
                  </c:pt>
                </c:numCache>
              </c:numRef>
            </c:plus>
            <c:minus>
              <c:numRef>
                <c:f>'sk-VCaP'!$AA$69:$AA$73</c:f>
                <c:numCache>
                  <c:formatCode>General</c:formatCode>
                  <c:ptCount val="5"/>
                  <c:pt idx="0">
                    <c:v>0.14442078296721883</c:v>
                  </c:pt>
                  <c:pt idx="1">
                    <c:v>0.23129622216290355</c:v>
                  </c:pt>
                  <c:pt idx="2">
                    <c:v>2.8867513459481284E-2</c:v>
                  </c:pt>
                  <c:pt idx="3">
                    <c:v>4.2189923590861607E-2</c:v>
                  </c:pt>
                  <c:pt idx="4">
                    <c:v>2.8867513459481284E-2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AA$60:$AA$64</c:f>
              <c:numCache>
                <c:formatCode>General</c:formatCode>
                <c:ptCount val="5"/>
                <c:pt idx="0">
                  <c:v>1.7549019607843137</c:v>
                </c:pt>
                <c:pt idx="1">
                  <c:v>2.4444444444444442</c:v>
                </c:pt>
                <c:pt idx="2">
                  <c:v>0.55000000000000004</c:v>
                </c:pt>
                <c:pt idx="3">
                  <c:v>0.36579520697167761</c:v>
                </c:pt>
                <c:pt idx="4">
                  <c:v>0.29542483660130719</c:v>
                </c:pt>
              </c:numCache>
            </c:numRef>
          </c:val>
        </c:ser>
        <c:ser>
          <c:idx val="4"/>
          <c:order val="4"/>
          <c:tx>
            <c:strRef>
              <c:f>'sk-VCaP'!$AB$59</c:f>
              <c:strCache>
                <c:ptCount val="1"/>
                <c:pt idx="0">
                  <c:v>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AB$69:$AB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0339729647468383</c:v>
                  </c:pt>
                  <c:pt idx="2">
                    <c:v>3.6740471675703511E-2</c:v>
                  </c:pt>
                  <c:pt idx="3">
                    <c:v>3.3333333333333326E-2</c:v>
                  </c:pt>
                  <c:pt idx="4">
                    <c:v>3.6740471675703511E-2</c:v>
                  </c:pt>
                </c:numCache>
              </c:numRef>
            </c:plus>
            <c:minus>
              <c:numRef>
                <c:f>'sk-VCaP'!$AB$69:$AB$7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0339729647468383</c:v>
                  </c:pt>
                  <c:pt idx="2">
                    <c:v>3.6740471675703511E-2</c:v>
                  </c:pt>
                  <c:pt idx="3">
                    <c:v>3.3333333333333326E-2</c:v>
                  </c:pt>
                  <c:pt idx="4">
                    <c:v>3.6740471675703511E-2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AB$60:$AB$64</c:f>
              <c:numCache>
                <c:formatCode>General</c:formatCode>
                <c:ptCount val="5"/>
                <c:pt idx="0">
                  <c:v>1</c:v>
                </c:pt>
                <c:pt idx="1">
                  <c:v>0.45303030303030295</c:v>
                </c:pt>
                <c:pt idx="2">
                  <c:v>1.2272727272727273</c:v>
                </c:pt>
                <c:pt idx="3">
                  <c:v>0.66666666666666663</c:v>
                </c:pt>
                <c:pt idx="4">
                  <c:v>1.5666666666666667</c:v>
                </c:pt>
              </c:numCache>
            </c:numRef>
          </c:val>
        </c:ser>
        <c:ser>
          <c:idx val="5"/>
          <c:order val="5"/>
          <c:tx>
            <c:strRef>
              <c:f>'sk-VCaP'!$AC$59</c:f>
              <c:strCache>
                <c:ptCount val="1"/>
                <c:pt idx="0">
                  <c:v>DOCETAXEL+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AC$69:$AC$73</c:f>
                <c:numCache>
                  <c:formatCode>General</c:formatCode>
                  <c:ptCount val="5"/>
                  <c:pt idx="0">
                    <c:v>5.841532516127098E-2</c:v>
                  </c:pt>
                  <c:pt idx="1">
                    <c:v>0.12410171057604856</c:v>
                  </c:pt>
                  <c:pt idx="2">
                    <c:v>3.1530779330363752E-2</c:v>
                  </c:pt>
                  <c:pt idx="3">
                    <c:v>6.4480531993958201E-2</c:v>
                  </c:pt>
                  <c:pt idx="4">
                    <c:v>4.0609162885102143E-3</c:v>
                  </c:pt>
                </c:numCache>
              </c:numRef>
            </c:plus>
            <c:minus>
              <c:numRef>
                <c:f>'sk-VCaP'!$AC$69:$AC$73</c:f>
                <c:numCache>
                  <c:formatCode>General</c:formatCode>
                  <c:ptCount val="5"/>
                  <c:pt idx="0">
                    <c:v>5.841532516127098E-2</c:v>
                  </c:pt>
                  <c:pt idx="1">
                    <c:v>0.12410171057604856</c:v>
                  </c:pt>
                  <c:pt idx="2">
                    <c:v>3.1530779330363752E-2</c:v>
                  </c:pt>
                  <c:pt idx="3">
                    <c:v>6.4480531993958201E-2</c:v>
                  </c:pt>
                  <c:pt idx="4">
                    <c:v>4.0609162885102143E-3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AC$60:$AC$64</c:f>
              <c:numCache>
                <c:formatCode>General</c:formatCode>
                <c:ptCount val="5"/>
                <c:pt idx="0">
                  <c:v>1.0067340067340067</c:v>
                </c:pt>
                <c:pt idx="1">
                  <c:v>1.2611111111111111</c:v>
                </c:pt>
                <c:pt idx="2">
                  <c:v>1.0593739250086001</c:v>
                </c:pt>
                <c:pt idx="3">
                  <c:v>0.54040404040404033</c:v>
                </c:pt>
                <c:pt idx="4">
                  <c:v>2.0377104377104374</c:v>
                </c:pt>
              </c:numCache>
            </c:numRef>
          </c:val>
        </c:ser>
        <c:ser>
          <c:idx val="6"/>
          <c:order val="6"/>
          <c:tx>
            <c:strRef>
              <c:f>'sk-VCaP'!$AD$59</c:f>
              <c:strCache>
                <c:ptCount val="1"/>
                <c:pt idx="0">
                  <c:v>GLIPR1-ΔTM + 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AD$69:$AD$73</c:f>
                <c:numCache>
                  <c:formatCode>General</c:formatCode>
                  <c:ptCount val="5"/>
                  <c:pt idx="0">
                    <c:v>8.1762668054252918E-2</c:v>
                  </c:pt>
                  <c:pt idx="1">
                    <c:v>0.13152059929307205</c:v>
                  </c:pt>
                  <c:pt idx="2">
                    <c:v>5.45516490837991E-2</c:v>
                  </c:pt>
                  <c:pt idx="3">
                    <c:v>1.5789473684210541E-2</c:v>
                  </c:pt>
                  <c:pt idx="4">
                    <c:v>4.5040630442034421E-2</c:v>
                  </c:pt>
                </c:numCache>
              </c:numRef>
            </c:plus>
            <c:minus>
              <c:numRef>
                <c:f>'sk-VCaP'!$AD$69:$AD$73</c:f>
                <c:numCache>
                  <c:formatCode>General</c:formatCode>
                  <c:ptCount val="5"/>
                  <c:pt idx="0">
                    <c:v>8.1762668054252918E-2</c:v>
                  </c:pt>
                  <c:pt idx="1">
                    <c:v>0.13152059929307205</c:v>
                  </c:pt>
                  <c:pt idx="2">
                    <c:v>5.45516490837991E-2</c:v>
                  </c:pt>
                  <c:pt idx="3">
                    <c:v>1.5789473684210541E-2</c:v>
                  </c:pt>
                  <c:pt idx="4">
                    <c:v>4.5040630442034421E-2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AD$60:$AD$64</c:f>
              <c:numCache>
                <c:formatCode>General</c:formatCode>
                <c:ptCount val="5"/>
                <c:pt idx="0">
                  <c:v>2.642105263157895</c:v>
                </c:pt>
                <c:pt idx="1">
                  <c:v>0.76296296296296295</c:v>
                </c:pt>
                <c:pt idx="2">
                  <c:v>0.69005847953216382</c:v>
                </c:pt>
                <c:pt idx="3">
                  <c:v>0.9157894736842106</c:v>
                </c:pt>
                <c:pt idx="4">
                  <c:v>2.1052631578947367</c:v>
                </c:pt>
              </c:numCache>
            </c:numRef>
          </c:val>
        </c:ser>
        <c:ser>
          <c:idx val="7"/>
          <c:order val="7"/>
          <c:tx>
            <c:strRef>
              <c:f>'sk-VCaP'!$AE$59</c:f>
              <c:strCache>
                <c:ptCount val="1"/>
                <c:pt idx="0">
                  <c:v>DOCETAXEL+ GLIPR1-ΔTM + 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VCaP'!$AE$69:$AE$73</c:f>
                <c:numCache>
                  <c:formatCode>General</c:formatCode>
                  <c:ptCount val="5"/>
                  <c:pt idx="0">
                    <c:v>3.3333333333333368E-2</c:v>
                  </c:pt>
                  <c:pt idx="1">
                    <c:v>7.3360578641281315E-2</c:v>
                  </c:pt>
                  <c:pt idx="2">
                    <c:v>3.50877192982461E-3</c:v>
                  </c:pt>
                  <c:pt idx="3">
                    <c:v>8.4700715748364949E-2</c:v>
                  </c:pt>
                  <c:pt idx="4">
                    <c:v>3.50877192982461E-3</c:v>
                  </c:pt>
                </c:numCache>
              </c:numRef>
            </c:plus>
            <c:minus>
              <c:numRef>
                <c:f>'sk-VCaP'!$AE$69:$AE$73</c:f>
                <c:numCache>
                  <c:formatCode>General</c:formatCode>
                  <c:ptCount val="5"/>
                  <c:pt idx="0">
                    <c:v>3.3333333333333368E-2</c:v>
                  </c:pt>
                  <c:pt idx="1">
                    <c:v>7.3360578641281315E-2</c:v>
                  </c:pt>
                  <c:pt idx="2">
                    <c:v>3.50877192982461E-3</c:v>
                  </c:pt>
                  <c:pt idx="3">
                    <c:v>8.4700715748364949E-2</c:v>
                  </c:pt>
                  <c:pt idx="4">
                    <c:v>3.50877192982461E-3</c:v>
                  </c:pt>
                </c:numCache>
              </c:numRef>
            </c:minus>
          </c:errBars>
          <c:cat>
            <c:strRef>
              <c:f>'sk-VCaP'!$W$60:$W$64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VCaP'!$AE$60:$AE$64</c:f>
              <c:numCache>
                <c:formatCode>General</c:formatCode>
                <c:ptCount val="5"/>
                <c:pt idx="0">
                  <c:v>2.9666666666666668</c:v>
                </c:pt>
                <c:pt idx="1">
                  <c:v>0.33</c:v>
                </c:pt>
                <c:pt idx="2">
                  <c:v>0.79649122807017536</c:v>
                </c:pt>
                <c:pt idx="3">
                  <c:v>1.2296296296296296</c:v>
                </c:pt>
                <c:pt idx="4">
                  <c:v>1.97037037037037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243840"/>
        <c:axId val="68245376"/>
      </c:barChart>
      <c:catAx>
        <c:axId val="68243840"/>
        <c:scaling>
          <c:orientation val="minMax"/>
        </c:scaling>
        <c:delete val="0"/>
        <c:axPos val="b"/>
        <c:majorTickMark val="out"/>
        <c:minorTickMark val="none"/>
        <c:tickLblPos val="nextTo"/>
        <c:crossAx val="68245376"/>
        <c:crosses val="autoZero"/>
        <c:auto val="1"/>
        <c:lblAlgn val="ctr"/>
        <c:lblOffset val="100"/>
        <c:noMultiLvlLbl val="0"/>
      </c:catAx>
      <c:valAx>
        <c:axId val="68245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82438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985367385414358"/>
          <c:y val="2.8601400923427204E-3"/>
          <c:w val="0.25861811426908898"/>
          <c:h val="0.87039101152705733"/>
        </c:manualLayout>
      </c:layout>
      <c:overlay val="0"/>
    </c:legend>
    <c:plotVisOnly val="1"/>
    <c:dispBlanksAs val="gap"/>
    <c:showDLblsOverMax val="0"/>
  </c:chart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7549200867281129E-2"/>
          <c:y val="5.1925047809033432E-2"/>
          <c:w val="0.64332642963351605"/>
          <c:h val="0.835588481051861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k-PC3'!$AA$67</c:f>
              <c:strCache>
                <c:ptCount val="1"/>
                <c:pt idx="0">
                  <c:v>DMSO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A$77:$AA$8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'sk-PC3'!$AA$77:$AA$8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A$68:$AA$72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sk-PC3'!$AB$67</c:f>
              <c:strCache>
                <c:ptCount val="1"/>
                <c:pt idx="0">
                  <c:v>DOCETAXE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B$77:$AB$81</c:f>
                <c:numCache>
                  <c:formatCode>General</c:formatCode>
                  <c:ptCount val="5"/>
                  <c:pt idx="0">
                    <c:v>3.0303030303030314E-2</c:v>
                  </c:pt>
                  <c:pt idx="1">
                    <c:v>1.6666666666666569E-2</c:v>
                  </c:pt>
                  <c:pt idx="2">
                    <c:v>3.0754216863915759E-2</c:v>
                  </c:pt>
                  <c:pt idx="3">
                    <c:v>1.8370235837851703E-2</c:v>
                  </c:pt>
                  <c:pt idx="4">
                    <c:v>2.9845023641806381E-2</c:v>
                  </c:pt>
                </c:numCache>
              </c:numRef>
            </c:plus>
            <c:minus>
              <c:numRef>
                <c:f>'sk-PC3'!$AB$77:$AB$81</c:f>
                <c:numCache>
                  <c:formatCode>General</c:formatCode>
                  <c:ptCount val="5"/>
                  <c:pt idx="0">
                    <c:v>3.0303030303030314E-2</c:v>
                  </c:pt>
                  <c:pt idx="1">
                    <c:v>1.6666666666666569E-2</c:v>
                  </c:pt>
                  <c:pt idx="2">
                    <c:v>3.0754216863915759E-2</c:v>
                  </c:pt>
                  <c:pt idx="3">
                    <c:v>1.8370235837851703E-2</c:v>
                  </c:pt>
                  <c:pt idx="4">
                    <c:v>2.9845023641806381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B$68:$AB$72</c:f>
              <c:numCache>
                <c:formatCode>General</c:formatCode>
                <c:ptCount val="5"/>
                <c:pt idx="0">
                  <c:v>0.96969696969696972</c:v>
                </c:pt>
                <c:pt idx="1">
                  <c:v>1.3833333333333331</c:v>
                </c:pt>
                <c:pt idx="2">
                  <c:v>1.1606060606060604</c:v>
                </c:pt>
                <c:pt idx="3">
                  <c:v>1.1136363636363635</c:v>
                </c:pt>
                <c:pt idx="4">
                  <c:v>1.2575757575757576</c:v>
                </c:pt>
              </c:numCache>
            </c:numRef>
          </c:val>
        </c:ser>
        <c:ser>
          <c:idx val="2"/>
          <c:order val="2"/>
          <c:tx>
            <c:strRef>
              <c:f>'sk-PC3'!$AC$67</c:f>
              <c:strCache>
                <c:ptCount val="1"/>
                <c:pt idx="0">
                  <c:v>GLIPR1-ΔT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C$77:$AC$81</c:f>
                <c:numCache>
                  <c:formatCode>General</c:formatCode>
                  <c:ptCount val="5"/>
                  <c:pt idx="0">
                    <c:v>5.7735026918962568E-2</c:v>
                  </c:pt>
                  <c:pt idx="1">
                    <c:v>6.4389734661836506E-2</c:v>
                  </c:pt>
                  <c:pt idx="2">
                    <c:v>4.8733975165585454E-2</c:v>
                  </c:pt>
                  <c:pt idx="3">
                    <c:v>0</c:v>
                  </c:pt>
                  <c:pt idx="4">
                    <c:v>2.8867513459481284E-2</c:v>
                  </c:pt>
                </c:numCache>
              </c:numRef>
            </c:plus>
            <c:minus>
              <c:numRef>
                <c:f>'sk-PC3'!$AC$77:$AC$81</c:f>
                <c:numCache>
                  <c:formatCode>General</c:formatCode>
                  <c:ptCount val="5"/>
                  <c:pt idx="0">
                    <c:v>5.7735026918962568E-2</c:v>
                  </c:pt>
                  <c:pt idx="1">
                    <c:v>6.4389734661836506E-2</c:v>
                  </c:pt>
                  <c:pt idx="2">
                    <c:v>4.8733975165585454E-2</c:v>
                  </c:pt>
                  <c:pt idx="3">
                    <c:v>0</c:v>
                  </c:pt>
                  <c:pt idx="4">
                    <c:v>2.8867513459481284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C$68:$AC$72</c:f>
              <c:numCache>
                <c:formatCode>General</c:formatCode>
                <c:ptCount val="5"/>
                <c:pt idx="0">
                  <c:v>1.5999999999999999</c:v>
                </c:pt>
                <c:pt idx="1">
                  <c:v>1.6261261261261264</c:v>
                </c:pt>
                <c:pt idx="2">
                  <c:v>0.78783882783882786</c:v>
                </c:pt>
                <c:pt idx="3">
                  <c:v>0.9</c:v>
                </c:pt>
                <c:pt idx="4">
                  <c:v>0.85000000000000009</c:v>
                </c:pt>
              </c:numCache>
            </c:numRef>
          </c:val>
        </c:ser>
        <c:ser>
          <c:idx val="3"/>
          <c:order val="3"/>
          <c:tx>
            <c:strRef>
              <c:f>'sk-PC3'!$AD$67</c:f>
              <c:strCache>
                <c:ptCount val="1"/>
                <c:pt idx="0">
                  <c:v>DOCETAXEL+GLIPR1-ΔT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D$77:$AD$81</c:f>
                <c:numCache>
                  <c:formatCode>General</c:formatCode>
                  <c:ptCount val="5"/>
                  <c:pt idx="0">
                    <c:v>8.1781455225779343E-2</c:v>
                  </c:pt>
                  <c:pt idx="1">
                    <c:v>4.5942942925909627E-2</c:v>
                  </c:pt>
                  <c:pt idx="2">
                    <c:v>4.0160141301736119E-2</c:v>
                  </c:pt>
                  <c:pt idx="3">
                    <c:v>6.2626262626262863E-2</c:v>
                  </c:pt>
                  <c:pt idx="4">
                    <c:v>2.8926850651506124E-2</c:v>
                  </c:pt>
                </c:numCache>
              </c:numRef>
            </c:plus>
            <c:minus>
              <c:numRef>
                <c:f>'sk-PC3'!$AD$77:$AD$81</c:f>
                <c:numCache>
                  <c:formatCode>General</c:formatCode>
                  <c:ptCount val="5"/>
                  <c:pt idx="0">
                    <c:v>8.1781455225779343E-2</c:v>
                  </c:pt>
                  <c:pt idx="1">
                    <c:v>4.5942942925909627E-2</c:v>
                  </c:pt>
                  <c:pt idx="2">
                    <c:v>4.0160141301736119E-2</c:v>
                  </c:pt>
                  <c:pt idx="3">
                    <c:v>6.2626262626262863E-2</c:v>
                  </c:pt>
                  <c:pt idx="4">
                    <c:v>2.8926850651506124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D$68:$AD$72</c:f>
              <c:numCache>
                <c:formatCode>General</c:formatCode>
                <c:ptCount val="5"/>
                <c:pt idx="0">
                  <c:v>1.409427609427609</c:v>
                </c:pt>
                <c:pt idx="1">
                  <c:v>1.8308080808080811</c:v>
                </c:pt>
                <c:pt idx="2">
                  <c:v>0.58012820512820518</c:v>
                </c:pt>
                <c:pt idx="3">
                  <c:v>0.57373737373737377</c:v>
                </c:pt>
                <c:pt idx="4">
                  <c:v>0.55185185185185182</c:v>
                </c:pt>
              </c:numCache>
            </c:numRef>
          </c:val>
        </c:ser>
        <c:ser>
          <c:idx val="4"/>
          <c:order val="4"/>
          <c:tx>
            <c:strRef>
              <c:f>'sk-PC3'!$AE$67</c:f>
              <c:strCache>
                <c:ptCount val="1"/>
                <c:pt idx="0">
                  <c:v>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E$77:$AE$81</c:f>
                <c:numCache>
                  <c:formatCode>General</c:formatCode>
                  <c:ptCount val="5"/>
                  <c:pt idx="0">
                    <c:v>5.841532516127098E-2</c:v>
                  </c:pt>
                  <c:pt idx="1">
                    <c:v>4.8517462322497713E-2</c:v>
                  </c:pt>
                  <c:pt idx="2">
                    <c:v>7.1453491651827891E-2</c:v>
                  </c:pt>
                  <c:pt idx="3">
                    <c:v>7.1646002530526651E-2</c:v>
                  </c:pt>
                  <c:pt idx="4">
                    <c:v>0.11635956393297767</c:v>
                  </c:pt>
                </c:numCache>
              </c:numRef>
            </c:plus>
            <c:minus>
              <c:numRef>
                <c:f>'sk-PC3'!$AE$77:$AE$81</c:f>
                <c:numCache>
                  <c:formatCode>General</c:formatCode>
                  <c:ptCount val="5"/>
                  <c:pt idx="0">
                    <c:v>5.841532516127098E-2</c:v>
                  </c:pt>
                  <c:pt idx="1">
                    <c:v>4.8517462322497713E-2</c:v>
                  </c:pt>
                  <c:pt idx="2">
                    <c:v>7.1453491651827891E-2</c:v>
                  </c:pt>
                  <c:pt idx="3">
                    <c:v>7.1646002530526651E-2</c:v>
                  </c:pt>
                  <c:pt idx="4">
                    <c:v>0.11635956393297767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E$68:$AE$72</c:f>
              <c:numCache>
                <c:formatCode>General</c:formatCode>
                <c:ptCount val="5"/>
                <c:pt idx="0">
                  <c:v>1.0067340067340067</c:v>
                </c:pt>
                <c:pt idx="1">
                  <c:v>0.81389986824769434</c:v>
                </c:pt>
                <c:pt idx="2">
                  <c:v>1.5030303030303029</c:v>
                </c:pt>
                <c:pt idx="3">
                  <c:v>1.3575757575757574</c:v>
                </c:pt>
                <c:pt idx="4">
                  <c:v>1.2117845117845116</c:v>
                </c:pt>
              </c:numCache>
            </c:numRef>
          </c:val>
        </c:ser>
        <c:ser>
          <c:idx val="5"/>
          <c:order val="5"/>
          <c:tx>
            <c:strRef>
              <c:f>'sk-PC3'!$AF$67</c:f>
              <c:strCache>
                <c:ptCount val="1"/>
                <c:pt idx="0">
                  <c:v>DOCETAXEL+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F$77:$AF$81</c:f>
                <c:numCache>
                  <c:formatCode>General</c:formatCode>
                  <c:ptCount val="5"/>
                  <c:pt idx="0">
                    <c:v>8.0720350806308641E-2</c:v>
                  </c:pt>
                  <c:pt idx="1">
                    <c:v>5.7084113916451039E-2</c:v>
                  </c:pt>
                  <c:pt idx="2">
                    <c:v>9.9708078710902287E-2</c:v>
                  </c:pt>
                  <c:pt idx="3">
                    <c:v>0.13639740613570608</c:v>
                  </c:pt>
                  <c:pt idx="4">
                    <c:v>8.333333333333319E-2</c:v>
                  </c:pt>
                </c:numCache>
              </c:numRef>
            </c:plus>
            <c:minus>
              <c:numRef>
                <c:f>'sk-PC3'!$AF$77:$AF$81</c:f>
                <c:numCache>
                  <c:formatCode>General</c:formatCode>
                  <c:ptCount val="5"/>
                  <c:pt idx="0">
                    <c:v>8.0720350806308641E-2</c:v>
                  </c:pt>
                  <c:pt idx="1">
                    <c:v>5.7084113916451039E-2</c:v>
                  </c:pt>
                  <c:pt idx="2">
                    <c:v>9.9708078710902287E-2</c:v>
                  </c:pt>
                  <c:pt idx="3">
                    <c:v>0.13639740613570608</c:v>
                  </c:pt>
                  <c:pt idx="4">
                    <c:v>8.333333333333319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F$68:$AF$72</c:f>
              <c:numCache>
                <c:formatCode>General</c:formatCode>
                <c:ptCount val="5"/>
                <c:pt idx="0">
                  <c:v>0.98148148148148151</c:v>
                </c:pt>
                <c:pt idx="1">
                  <c:v>1.2601010101010102</c:v>
                </c:pt>
                <c:pt idx="2">
                  <c:v>1.7648148148148148</c:v>
                </c:pt>
                <c:pt idx="3">
                  <c:v>1.4907407407407407</c:v>
                </c:pt>
                <c:pt idx="4">
                  <c:v>0.91666666666666663</c:v>
                </c:pt>
              </c:numCache>
            </c:numRef>
          </c:val>
        </c:ser>
        <c:ser>
          <c:idx val="6"/>
          <c:order val="6"/>
          <c:tx>
            <c:strRef>
              <c:f>'sk-PC3'!$AG$67</c:f>
              <c:strCache>
                <c:ptCount val="1"/>
                <c:pt idx="0">
                  <c:v>GLIPR1-ΔTM + 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G$77:$AG$81</c:f>
                <c:numCache>
                  <c:formatCode>General</c:formatCode>
                  <c:ptCount val="5"/>
                  <c:pt idx="0">
                    <c:v>7.8860688967715836E-2</c:v>
                  </c:pt>
                  <c:pt idx="1">
                    <c:v>5.5690836210573073E-2</c:v>
                  </c:pt>
                  <c:pt idx="2">
                    <c:v>0.11212121212121211</c:v>
                  </c:pt>
                  <c:pt idx="3">
                    <c:v>6.0606060606061005E-3</c:v>
                  </c:pt>
                  <c:pt idx="4">
                    <c:v>2.756576575554584E-2</c:v>
                  </c:pt>
                </c:numCache>
              </c:numRef>
            </c:plus>
            <c:minus>
              <c:numRef>
                <c:f>'sk-PC3'!$AG$77:$AG$81</c:f>
                <c:numCache>
                  <c:formatCode>General</c:formatCode>
                  <c:ptCount val="5"/>
                  <c:pt idx="0">
                    <c:v>7.8860688967715836E-2</c:v>
                  </c:pt>
                  <c:pt idx="1">
                    <c:v>5.5690836210573073E-2</c:v>
                  </c:pt>
                  <c:pt idx="2">
                    <c:v>0.11212121212121211</c:v>
                  </c:pt>
                  <c:pt idx="3">
                    <c:v>6.0606060606061005E-3</c:v>
                  </c:pt>
                  <c:pt idx="4">
                    <c:v>2.756576575554584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G$68:$AG$72</c:f>
              <c:numCache>
                <c:formatCode>General</c:formatCode>
                <c:ptCount val="5"/>
                <c:pt idx="0">
                  <c:v>1.8590909090909091</c:v>
                </c:pt>
                <c:pt idx="1">
                  <c:v>1.471212121212121</c:v>
                </c:pt>
                <c:pt idx="2">
                  <c:v>1.5878787878787879</c:v>
                </c:pt>
                <c:pt idx="3">
                  <c:v>1.1939393939393941</c:v>
                </c:pt>
                <c:pt idx="4">
                  <c:v>1.5015151515151517</c:v>
                </c:pt>
              </c:numCache>
            </c:numRef>
          </c:val>
        </c:ser>
        <c:ser>
          <c:idx val="7"/>
          <c:order val="7"/>
          <c:tx>
            <c:strRef>
              <c:f>'sk-PC3'!$AH$67</c:f>
              <c:strCache>
                <c:ptCount val="1"/>
                <c:pt idx="0">
                  <c:v>DOCETAXEL+ GLIPR1-ΔTM + SP600125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PC3'!$AH$77:$AH$81</c:f>
                <c:numCache>
                  <c:formatCode>General</c:formatCode>
                  <c:ptCount val="5"/>
                  <c:pt idx="0">
                    <c:v>0.15000000000000088</c:v>
                  </c:pt>
                  <c:pt idx="1">
                    <c:v>2.8458150680769217E-2</c:v>
                  </c:pt>
                  <c:pt idx="2">
                    <c:v>0.10392785223750735</c:v>
                  </c:pt>
                  <c:pt idx="3">
                    <c:v>9.8287811183078472E-2</c:v>
                  </c:pt>
                  <c:pt idx="4">
                    <c:v>6.1864048475889118E-2</c:v>
                  </c:pt>
                </c:numCache>
              </c:numRef>
            </c:plus>
            <c:minus>
              <c:numRef>
                <c:f>'sk-PC3'!$AH$77:$AH$81</c:f>
                <c:numCache>
                  <c:formatCode>General</c:formatCode>
                  <c:ptCount val="5"/>
                  <c:pt idx="0">
                    <c:v>0.15000000000000088</c:v>
                  </c:pt>
                  <c:pt idx="1">
                    <c:v>2.8458150680769217E-2</c:v>
                  </c:pt>
                  <c:pt idx="2">
                    <c:v>0.10392785223750735</c:v>
                  </c:pt>
                  <c:pt idx="3">
                    <c:v>9.8287811183078472E-2</c:v>
                  </c:pt>
                  <c:pt idx="4">
                    <c:v>6.1864048475889118E-2</c:v>
                  </c:pt>
                </c:numCache>
              </c:numRef>
            </c:minus>
          </c:errBars>
          <c:cat>
            <c:strRef>
              <c:f>'sk-PC3'!$Z$68:$Z$72</c:f>
              <c:strCache>
                <c:ptCount val="5"/>
                <c:pt idx="0">
                  <c:v>GLIPR-1</c:v>
                </c:pt>
                <c:pt idx="1">
                  <c:v>P-JNK/JNK</c:v>
                </c:pt>
                <c:pt idx="2">
                  <c:v>P-ERK1/2/ERK1/2</c:v>
                </c:pt>
                <c:pt idx="3">
                  <c:v>CXCR4</c:v>
                </c:pt>
                <c:pt idx="4">
                  <c:v>C-MYC</c:v>
                </c:pt>
              </c:strCache>
            </c:strRef>
          </c:cat>
          <c:val>
            <c:numRef>
              <c:f>'sk-PC3'!$AH$68:$AH$72</c:f>
              <c:numCache>
                <c:formatCode>General</c:formatCode>
                <c:ptCount val="5"/>
                <c:pt idx="0">
                  <c:v>2.0500000000000003</c:v>
                </c:pt>
                <c:pt idx="1">
                  <c:v>1.1338383838383839</c:v>
                </c:pt>
                <c:pt idx="2">
                  <c:v>1.5105401844532278</c:v>
                </c:pt>
                <c:pt idx="3">
                  <c:v>1.5277777777777779</c:v>
                </c:pt>
                <c:pt idx="4">
                  <c:v>1.3777777777777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453888"/>
        <c:axId val="70467968"/>
      </c:barChart>
      <c:catAx>
        <c:axId val="70453888"/>
        <c:scaling>
          <c:orientation val="minMax"/>
        </c:scaling>
        <c:delete val="0"/>
        <c:axPos val="b"/>
        <c:majorTickMark val="out"/>
        <c:minorTickMark val="none"/>
        <c:tickLblPos val="nextTo"/>
        <c:crossAx val="70467968"/>
        <c:crosses val="autoZero"/>
        <c:auto val="1"/>
        <c:lblAlgn val="ctr"/>
        <c:lblOffset val="100"/>
        <c:noMultiLvlLbl val="0"/>
      </c:catAx>
      <c:valAx>
        <c:axId val="704679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04538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120988226008622"/>
          <c:y val="4.4792267770359016E-2"/>
          <c:w val="0.25009905755603279"/>
          <c:h val="0.84493890791757365"/>
        </c:manualLayout>
      </c:layout>
      <c:overlay val="0"/>
    </c:legend>
    <c:plotVisOnly val="1"/>
    <c:dispBlanksAs val="gap"/>
    <c:showDLblsOverMax val="0"/>
  </c:chart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k-cxcr4si vcap-pc3'!$F$12</c:f>
              <c:strCache>
                <c:ptCount val="1"/>
                <c:pt idx="0">
                  <c:v>CXCR4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cxcr4si vcap-pc3'!$B$16:$D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3834776186331928E-2</c:v>
                  </c:pt>
                  <c:pt idx="2">
                    <c:v>3.0754216863915822E-2</c:v>
                  </c:pt>
                </c:numCache>
              </c:numRef>
            </c:plus>
            <c:minus>
              <c:numRef>
                <c:f>'sk-cxcr4si vcap-pc3'!$B$16:$D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3834776186331928E-2</c:v>
                  </c:pt>
                  <c:pt idx="2">
                    <c:v>3.0754216863915822E-2</c:v>
                  </c:pt>
                </c:numCache>
              </c:numRef>
            </c:minus>
          </c:errBars>
          <c:cat>
            <c:strRef>
              <c:f>'sk-cxcr4si vcap-pc3'!$G$11:$I$11</c:f>
              <c:strCache>
                <c:ptCount val="3"/>
                <c:pt idx="0">
                  <c:v>NCsi</c:v>
                </c:pt>
                <c:pt idx="1">
                  <c:v>CXCR4si7</c:v>
                </c:pt>
                <c:pt idx="2">
                  <c:v>CXCR4si8</c:v>
                </c:pt>
              </c:strCache>
            </c:strRef>
          </c:cat>
          <c:val>
            <c:numRef>
              <c:f>'sk-cxcr4si vcap-pc3'!$G$12:$I$12</c:f>
              <c:numCache>
                <c:formatCode>General</c:formatCode>
                <c:ptCount val="3"/>
                <c:pt idx="0">
                  <c:v>1</c:v>
                </c:pt>
                <c:pt idx="1">
                  <c:v>0.4681818181818182</c:v>
                </c:pt>
                <c:pt idx="2">
                  <c:v>0.839393939393939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776384"/>
        <c:axId val="77777920"/>
      </c:barChart>
      <c:catAx>
        <c:axId val="77776384"/>
        <c:scaling>
          <c:orientation val="minMax"/>
        </c:scaling>
        <c:delete val="0"/>
        <c:axPos val="b"/>
        <c:majorTickMark val="out"/>
        <c:minorTickMark val="none"/>
        <c:tickLblPos val="nextTo"/>
        <c:crossAx val="77777920"/>
        <c:crosses val="autoZero"/>
        <c:auto val="1"/>
        <c:lblAlgn val="ctr"/>
        <c:lblOffset val="100"/>
        <c:noMultiLvlLbl val="0"/>
      </c:catAx>
      <c:valAx>
        <c:axId val="77777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777638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k-cxcr4si vcap-pc3'!$F$29</c:f>
              <c:strCache>
                <c:ptCount val="1"/>
                <c:pt idx="0">
                  <c:v>CXCR4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k-cxcr4si vcap-pc3'!$B$32:$D$3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6120132998489529E-2</c:v>
                  </c:pt>
                  <c:pt idx="2">
                    <c:v>5.7861355281894934E-2</c:v>
                  </c:pt>
                </c:numCache>
              </c:numRef>
            </c:plus>
            <c:minus>
              <c:numRef>
                <c:f>'sk-cxcr4si vcap-pc3'!$B$32:$D$3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6120132998489529E-2</c:v>
                  </c:pt>
                  <c:pt idx="2">
                    <c:v>5.7861355281894934E-2</c:v>
                  </c:pt>
                </c:numCache>
              </c:numRef>
            </c:minus>
          </c:errBars>
          <c:cat>
            <c:strRef>
              <c:f>'sk-cxcr4si vcap-pc3'!$G$28:$I$28</c:f>
              <c:strCache>
                <c:ptCount val="3"/>
                <c:pt idx="0">
                  <c:v>NCsi</c:v>
                </c:pt>
                <c:pt idx="1">
                  <c:v>CXCR4si7</c:v>
                </c:pt>
                <c:pt idx="2">
                  <c:v>CXCR4si8</c:v>
                </c:pt>
              </c:strCache>
            </c:strRef>
          </c:cat>
          <c:val>
            <c:numRef>
              <c:f>'sk-cxcr4si vcap-pc3'!$G$29:$I$29</c:f>
              <c:numCache>
                <c:formatCode>General</c:formatCode>
                <c:ptCount val="3"/>
                <c:pt idx="0">
                  <c:v>1</c:v>
                </c:pt>
                <c:pt idx="1">
                  <c:v>0.38510101010101011</c:v>
                </c:pt>
                <c:pt idx="2">
                  <c:v>0.656313131313131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789824"/>
        <c:axId val="77885824"/>
      </c:barChart>
      <c:catAx>
        <c:axId val="77789824"/>
        <c:scaling>
          <c:orientation val="minMax"/>
        </c:scaling>
        <c:delete val="0"/>
        <c:axPos val="b"/>
        <c:majorTickMark val="out"/>
        <c:minorTickMark val="none"/>
        <c:tickLblPos val="nextTo"/>
        <c:crossAx val="77885824"/>
        <c:crosses val="autoZero"/>
        <c:auto val="1"/>
        <c:lblAlgn val="ctr"/>
        <c:lblOffset val="100"/>
        <c:noMultiLvlLbl val="0"/>
      </c:catAx>
      <c:valAx>
        <c:axId val="77885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77898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69</cdr:x>
      <cdr:y>0.03164</cdr:y>
    </cdr:from>
    <cdr:to>
      <cdr:x>0.05187</cdr:x>
      <cdr:y>0.87505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724645" y="951257"/>
          <a:ext cx="2057401" cy="30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b="1" dirty="0" smtClean="0"/>
            <a:t>Densitometry (fold changes)</a:t>
          </a:r>
          <a:endParaRPr lang="en-US" sz="11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207</cdr:x>
      <cdr:y>0.04713</cdr:y>
    </cdr:from>
    <cdr:to>
      <cdr:x>0.05616</cdr:x>
      <cdr:y>0.88776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786495" y="1114707"/>
          <a:ext cx="2282701" cy="30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b="1" dirty="0" smtClean="0"/>
            <a:t>Densitometry (fold changes)</a:t>
          </a:r>
          <a:endParaRPr lang="en-US" sz="11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891792-0BAE-4FCF-9616-42409A92975A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3E3C56-6C41-4FB7-9FCD-AFE0A00F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629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Quantitative Data of Westerns Blots (relevant to Figure 4A, B). A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Ca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nsitomentr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ta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-3 cells densitometry data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DA3CE8-8BC3-49FE-BAD1-DE58006DA94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569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Quantitative data of Western Blots on 2 different CXCR4siRNAs for validation and determination of their effect size (relevant to Figure 5A). A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XCR4si7 is statistically significant in inhibiting CXCR4 protein expression tha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Cs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(p&lt;0.001) and CXCR4si8 is (p=0.002) i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Ca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XCR4si7 is statistically significant in inhibiting CXCR4 protein expression tha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Cs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(p&lt;0.001) and CXCR4si8 is (p=0.01) in PC-3 cells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DA3CE8-8BC3-49FE-BAD1-DE58006DA94A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361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156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40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133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572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606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776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789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721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463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04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694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42F6B0-BA27-4B74-9C19-597C7CFC3618}" type="datetimeFigureOut">
              <a:rPr lang="en-US" smtClean="0"/>
              <a:t>5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FF569-E907-4289-9596-CB01B8782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783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167390" y="0"/>
            <a:ext cx="29286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Supplementary data</a:t>
            </a:r>
            <a:endParaRPr lang="en-US" sz="2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772400" y="0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 smtClean="0"/>
              <a:t>Figure S1</a:t>
            </a:r>
            <a:endParaRPr lang="en-US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0" y="572984"/>
            <a:ext cx="3190875" cy="493816"/>
            <a:chOff x="0" y="425049"/>
            <a:chExt cx="3190875" cy="493816"/>
          </a:xfrm>
        </p:grpSpPr>
        <p:sp>
          <p:nvSpPr>
            <p:cNvPr id="12" name="TextBox 11"/>
            <p:cNvSpPr txBox="1"/>
            <p:nvPr/>
          </p:nvSpPr>
          <p:spPr>
            <a:xfrm>
              <a:off x="0" y="457200"/>
              <a:ext cx="606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/>
                <a:t>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362075" y="425049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/>
                <a:t>VCaP</a:t>
              </a:r>
              <a:r>
                <a:rPr lang="en-US" b="1" dirty="0" smtClean="0"/>
                <a:t> cells</a:t>
              </a:r>
              <a:endParaRPr lang="en-US" b="1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29688" y="3640270"/>
            <a:ext cx="3137702" cy="474530"/>
            <a:chOff x="29688" y="3119735"/>
            <a:chExt cx="3137702" cy="474530"/>
          </a:xfrm>
        </p:grpSpPr>
        <p:sp>
          <p:nvSpPr>
            <p:cNvPr id="13" name="TextBox 12"/>
            <p:cNvSpPr txBox="1"/>
            <p:nvPr/>
          </p:nvSpPr>
          <p:spPr>
            <a:xfrm>
              <a:off x="29688" y="3119735"/>
              <a:ext cx="606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B</a:t>
              </a:r>
              <a:endParaRPr lang="en-US" sz="24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338590" y="3224933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PC-3 cells</a:t>
              </a:r>
              <a:endParaRPr lang="en-US" b="1" dirty="0"/>
            </a:p>
          </p:txBody>
        </p:sp>
      </p:grp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567518"/>
              </p:ext>
            </p:extLst>
          </p:nvPr>
        </p:nvGraphicFramePr>
        <p:xfrm>
          <a:off x="147931" y="942317"/>
          <a:ext cx="8843669" cy="2803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1916945"/>
              </p:ext>
            </p:extLst>
          </p:nvPr>
        </p:nvGraphicFramePr>
        <p:xfrm>
          <a:off x="71570" y="3930135"/>
          <a:ext cx="9072430" cy="2927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0094802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772400" y="-6927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 smtClean="0"/>
              <a:t>Figure </a:t>
            </a:r>
            <a:r>
              <a:rPr lang="en-US" sz="2000" b="1" dirty="0"/>
              <a:t>S</a:t>
            </a:r>
            <a:r>
              <a:rPr lang="en-US" sz="2000" b="1" dirty="0" smtClean="0"/>
              <a:t>2</a:t>
            </a:r>
            <a:endParaRPr 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167390" y="0"/>
            <a:ext cx="29286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Supplementary data</a:t>
            </a:r>
            <a:endParaRPr lang="en-US" sz="2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1209675" y="457200"/>
            <a:ext cx="5800725" cy="3048000"/>
            <a:chOff x="1209675" y="457200"/>
            <a:chExt cx="5800725" cy="2752199"/>
          </a:xfrm>
        </p:grpSpPr>
        <p:sp>
          <p:nvSpPr>
            <p:cNvPr id="10" name="TextBox 9"/>
            <p:cNvSpPr txBox="1"/>
            <p:nvPr/>
          </p:nvSpPr>
          <p:spPr>
            <a:xfrm>
              <a:off x="1209675" y="457200"/>
              <a:ext cx="606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A</a:t>
              </a:r>
            </a:p>
          </p:txBody>
        </p:sp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4681646"/>
                </p:ext>
              </p:extLst>
            </p:nvPr>
          </p:nvGraphicFramePr>
          <p:xfrm>
            <a:off x="2590800" y="925631"/>
            <a:ext cx="4419600" cy="22837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1560115" y="516576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/>
                <a:t>VCaP</a:t>
              </a:r>
              <a:r>
                <a:rPr lang="en-US" b="1" dirty="0" smtClean="0"/>
                <a:t> cells</a:t>
              </a:r>
              <a:endParaRPr lang="en-US" b="1" dirty="0"/>
            </a:p>
          </p:txBody>
        </p:sp>
        <p:sp>
          <p:nvSpPr>
            <p:cNvPr id="20" name="TextBox 1"/>
            <p:cNvSpPr txBox="1"/>
            <p:nvPr/>
          </p:nvSpPr>
          <p:spPr>
            <a:xfrm rot="16200000">
              <a:off x="1413676" y="1802114"/>
              <a:ext cx="1877702" cy="30927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 smtClean="0"/>
                <a:t>Densitometry (fold changes)</a:t>
              </a:r>
              <a:endParaRPr lang="en-US" sz="1100" b="1" dirty="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1219199" y="3505200"/>
            <a:ext cx="5791201" cy="3200400"/>
            <a:chOff x="1219199" y="3208409"/>
            <a:chExt cx="5791201" cy="3344791"/>
          </a:xfrm>
        </p:grpSpPr>
        <p:sp>
          <p:nvSpPr>
            <p:cNvPr id="11" name="TextBox 10"/>
            <p:cNvSpPr txBox="1"/>
            <p:nvPr/>
          </p:nvSpPr>
          <p:spPr>
            <a:xfrm>
              <a:off x="1219199" y="3208409"/>
              <a:ext cx="606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/>
                <a:t>B</a:t>
              </a:r>
              <a:endParaRPr lang="en-US" sz="2400" b="1" dirty="0"/>
            </a:p>
          </p:txBody>
        </p:sp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68189582"/>
                </p:ext>
              </p:extLst>
            </p:nvPr>
          </p:nvGraphicFramePr>
          <p:xfrm>
            <a:off x="2590800" y="3810000"/>
            <a:ext cx="4419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9" name="TextBox 18"/>
            <p:cNvSpPr txBox="1"/>
            <p:nvPr/>
          </p:nvSpPr>
          <p:spPr>
            <a:xfrm>
              <a:off x="1592761" y="3284439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PC-3 cells</a:t>
              </a:r>
              <a:endParaRPr lang="en-US" b="1" dirty="0"/>
            </a:p>
          </p:txBody>
        </p:sp>
        <p:sp>
          <p:nvSpPr>
            <p:cNvPr id="21" name="TextBox 1"/>
            <p:cNvSpPr txBox="1"/>
            <p:nvPr/>
          </p:nvSpPr>
          <p:spPr>
            <a:xfrm rot="16200000">
              <a:off x="1131092" y="4950765"/>
              <a:ext cx="2438400" cy="30927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 smtClean="0"/>
                <a:t>Densitometry (fold changes)</a:t>
              </a:r>
              <a:endParaRPr lang="en-US" sz="1100" b="1" dirty="0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4669794" y="1805049"/>
            <a:ext cx="473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4631695" y="5181600"/>
            <a:ext cx="549905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1996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3</Words>
  <Application>Microsoft Office PowerPoint</Application>
  <PresentationFormat>On-screen Show (4:3)</PresentationFormat>
  <Paragraphs>22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anika,  Styliani</dc:creator>
  <cp:lastModifiedBy>Karanika,  Styliani</cp:lastModifiedBy>
  <cp:revision>2</cp:revision>
  <dcterms:created xsi:type="dcterms:W3CDTF">2015-05-27T18:50:51Z</dcterms:created>
  <dcterms:modified xsi:type="dcterms:W3CDTF">2015-05-27T18:53:54Z</dcterms:modified>
</cp:coreProperties>
</file>